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93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55A11"/>
    <a:srgbClr val="54823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6614" autoAdjust="0"/>
    <p:restoredTop sz="94660"/>
  </p:normalViewPr>
  <p:slideViewPr>
    <p:cSldViewPr snapToGrid="0">
      <p:cViewPr varScale="1">
        <p:scale>
          <a:sx n="46" d="100"/>
          <a:sy n="46" d="100"/>
        </p:scale>
        <p:origin x="2580" y="5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高</c:v>
          </c:tx>
          <c:spPr>
            <a:ln w="28575">
              <a:solidFill>
                <a:srgbClr val="C55A11"/>
              </a:solidFill>
            </a:ln>
          </c:spPr>
          <c:marker>
            <c:symbol val="circle"/>
            <c:size val="4"/>
            <c:spPr>
              <a:solidFill>
                <a:srgbClr val="C55A11"/>
              </a:solidFill>
              <a:ln>
                <a:solidFill>
                  <a:srgbClr val="C55A11"/>
                </a:solidFill>
              </a:ln>
            </c:spPr>
          </c:marker>
          <c:xVal>
            <c:numRef>
              <c:f>'生存－UC'!$Z$27:$Z$38</c:f>
              <c:numCache>
                <c:formatCode>General</c:formatCode>
                <c:ptCount val="12"/>
                <c:pt idx="0">
                  <c:v>0</c:v>
                </c:pt>
                <c:pt idx="1">
                  <c:v>23</c:v>
                </c:pt>
                <c:pt idx="2">
                  <c:v>23</c:v>
                </c:pt>
                <c:pt idx="3">
                  <c:v>52</c:v>
                </c:pt>
                <c:pt idx="4">
                  <c:v>57</c:v>
                </c:pt>
                <c:pt idx="5">
                  <c:v>57</c:v>
                </c:pt>
                <c:pt idx="6">
                  <c:v>76</c:v>
                </c:pt>
                <c:pt idx="7">
                  <c:v>84</c:v>
                </c:pt>
                <c:pt idx="8">
                  <c:v>84</c:v>
                </c:pt>
                <c:pt idx="9">
                  <c:v>102</c:v>
                </c:pt>
                <c:pt idx="10">
                  <c:v>252</c:v>
                </c:pt>
                <c:pt idx="11">
                  <c:v>382</c:v>
                </c:pt>
              </c:numCache>
            </c:numRef>
          </c:xVal>
          <c:yVal>
            <c:numRef>
              <c:f>'生存－UC'!$AA$27:$AA$38</c:f>
              <c:numCache>
                <c:formatCode>General</c:formatCode>
                <c:ptCount val="12"/>
                <c:pt idx="0">
                  <c:v>1</c:v>
                </c:pt>
                <c:pt idx="1">
                  <c:v>1</c:v>
                </c:pt>
                <c:pt idx="2">
                  <c:v>0.88888888888888884</c:v>
                </c:pt>
                <c:pt idx="3">
                  <c:v>0.88888888888888884</c:v>
                </c:pt>
                <c:pt idx="4">
                  <c:v>0.88888888888888884</c:v>
                </c:pt>
                <c:pt idx="5">
                  <c:v>0.88888888888888884</c:v>
                </c:pt>
                <c:pt idx="6">
                  <c:v>0.88888888888888884</c:v>
                </c:pt>
                <c:pt idx="7">
                  <c:v>0.88888888888888884</c:v>
                </c:pt>
                <c:pt idx="8">
                  <c:v>0.66666666666666663</c:v>
                </c:pt>
                <c:pt idx="9">
                  <c:v>0.66666666666666663</c:v>
                </c:pt>
                <c:pt idx="10">
                  <c:v>0.66666666666666663</c:v>
                </c:pt>
                <c:pt idx="11">
                  <c:v>0.6666666666666666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923-4FFE-9286-8F09E57F5A3E}"/>
            </c:ext>
          </c:extLst>
        </c:ser>
        <c:ser>
          <c:idx val="1"/>
          <c:order val="1"/>
          <c:tx>
            <c:v>低</c:v>
          </c:tx>
          <c:spPr>
            <a:ln w="28575">
              <a:solidFill>
                <a:srgbClr val="548235"/>
              </a:solidFill>
            </a:ln>
          </c:spPr>
          <c:marker>
            <c:symbol val="circle"/>
            <c:size val="4"/>
            <c:spPr>
              <a:solidFill>
                <a:srgbClr val="548235"/>
              </a:solidFill>
              <a:ln>
                <a:solidFill>
                  <a:srgbClr val="548235"/>
                </a:solidFill>
              </a:ln>
            </c:spPr>
          </c:marker>
          <c:xVal>
            <c:numLit>
              <c:formatCode>General</c:formatCode>
              <c:ptCount val="17"/>
              <c:pt idx="0">
                <c:v>0</c:v>
              </c:pt>
              <c:pt idx="1">
                <c:v>12</c:v>
              </c:pt>
              <c:pt idx="2">
                <c:v>12</c:v>
              </c:pt>
              <c:pt idx="3">
                <c:v>21</c:v>
              </c:pt>
              <c:pt idx="4">
                <c:v>21</c:v>
              </c:pt>
              <c:pt idx="5">
                <c:v>33</c:v>
              </c:pt>
              <c:pt idx="6">
                <c:v>33</c:v>
              </c:pt>
              <c:pt idx="7">
                <c:v>49</c:v>
              </c:pt>
              <c:pt idx="8">
                <c:v>49</c:v>
              </c:pt>
              <c:pt idx="9">
                <c:v>54</c:v>
              </c:pt>
              <c:pt idx="10">
                <c:v>54</c:v>
              </c:pt>
              <c:pt idx="11">
                <c:v>132</c:v>
              </c:pt>
              <c:pt idx="12">
                <c:v>133</c:v>
              </c:pt>
              <c:pt idx="13">
                <c:v>133</c:v>
              </c:pt>
              <c:pt idx="14">
                <c:v>232</c:v>
              </c:pt>
              <c:pt idx="15">
                <c:v>295</c:v>
              </c:pt>
              <c:pt idx="16">
                <c:v>440</c:v>
              </c:pt>
            </c:numLit>
          </c:xVal>
          <c:yVal>
            <c:numLit>
              <c:formatCode>General</c:formatCode>
              <c:ptCount val="17"/>
              <c:pt idx="0">
                <c:v>1</c:v>
              </c:pt>
              <c:pt idx="1">
                <c:v>1</c:v>
              </c:pt>
              <c:pt idx="2">
                <c:v>0.9</c:v>
              </c:pt>
              <c:pt idx="3">
                <c:v>0.9</c:v>
              </c:pt>
              <c:pt idx="4">
                <c:v>0.8</c:v>
              </c:pt>
              <c:pt idx="5">
                <c:v>0.8</c:v>
              </c:pt>
              <c:pt idx="6">
                <c:v>0.70000000000000007</c:v>
              </c:pt>
              <c:pt idx="7">
                <c:v>0.70000000000000007</c:v>
              </c:pt>
              <c:pt idx="8">
                <c:v>0.60000000000000009</c:v>
              </c:pt>
              <c:pt idx="9">
                <c:v>0.60000000000000009</c:v>
              </c:pt>
              <c:pt idx="10">
                <c:v>0.50000000000000011</c:v>
              </c:pt>
              <c:pt idx="11">
                <c:v>0.50000000000000011</c:v>
              </c:pt>
              <c:pt idx="12">
                <c:v>0.50000000000000011</c:v>
              </c:pt>
              <c:pt idx="13">
                <c:v>0.37500000000000011</c:v>
              </c:pt>
              <c:pt idx="14">
                <c:v>0.37500000000000011</c:v>
              </c:pt>
              <c:pt idx="15">
                <c:v>0.37500000000000011</c:v>
              </c:pt>
              <c:pt idx="16">
                <c:v>0.37500000000000011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1-E923-4FFE-9286-8F09E57F5A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7025544"/>
        <c:axId val="697028824"/>
      </c:scatterChart>
      <c:valAx>
        <c:axId val="6970255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9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ja-JP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after ADA</a:t>
                </a:r>
                <a:r>
                  <a:rPr lang="en-US" altLang="ja-JP" sz="900" b="0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induction (weeks)</a:t>
                </a:r>
                <a:endParaRPr lang="ja-JP" altLang="en-US" sz="9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697028824"/>
        <c:crosses val="autoZero"/>
        <c:crossBetween val="midCat"/>
      </c:valAx>
      <c:valAx>
        <c:axId val="697028824"/>
        <c:scaling>
          <c:orientation val="minMax"/>
          <c:max val="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altLang="ja-JP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rsistence rates with ADA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697025544"/>
        <c:crosses val="autoZero"/>
        <c:crossBetween val="midCat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ln>
      <a:solidFill>
        <a:schemeClr val="bg2">
          <a:lumMod val="75000"/>
        </a:schemeClr>
      </a:solidFill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高</c:v>
          </c:tx>
          <c:spPr>
            <a:ln w="28575">
              <a:solidFill>
                <a:srgbClr val="C55A11"/>
              </a:solidFill>
            </a:ln>
          </c:spPr>
          <c:marker>
            <c:symbol val="circle"/>
            <c:size val="4"/>
            <c:spPr>
              <a:solidFill>
                <a:srgbClr val="C55A11"/>
              </a:solidFill>
              <a:ln>
                <a:solidFill>
                  <a:srgbClr val="C55A11"/>
                </a:solidFill>
              </a:ln>
            </c:spPr>
          </c:marker>
          <c:xVal>
            <c:numRef>
              <c:f>'生存－CD'!$Z$41:$Z$53</c:f>
              <c:numCache>
                <c:formatCode>General</c:formatCode>
                <c:ptCount val="13"/>
                <c:pt idx="0">
                  <c:v>0</c:v>
                </c:pt>
                <c:pt idx="1">
                  <c:v>44</c:v>
                </c:pt>
                <c:pt idx="2">
                  <c:v>87</c:v>
                </c:pt>
                <c:pt idx="3">
                  <c:v>87</c:v>
                </c:pt>
                <c:pt idx="4">
                  <c:v>140</c:v>
                </c:pt>
                <c:pt idx="5">
                  <c:v>166</c:v>
                </c:pt>
                <c:pt idx="6">
                  <c:v>187</c:v>
                </c:pt>
                <c:pt idx="7">
                  <c:v>211</c:v>
                </c:pt>
                <c:pt idx="8">
                  <c:v>286</c:v>
                </c:pt>
                <c:pt idx="9">
                  <c:v>286</c:v>
                </c:pt>
                <c:pt idx="10">
                  <c:v>298</c:v>
                </c:pt>
                <c:pt idx="11">
                  <c:v>298</c:v>
                </c:pt>
                <c:pt idx="12">
                  <c:v>593</c:v>
                </c:pt>
              </c:numCache>
            </c:numRef>
          </c:xVal>
          <c:yVal>
            <c:numRef>
              <c:f>'生存－CD'!$AA$41:$AA$53</c:f>
              <c:numCache>
                <c:formatCode>General</c:formatCode>
                <c:ptCount val="13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0.875</c:v>
                </c:pt>
                <c:pt idx="4">
                  <c:v>0.875</c:v>
                </c:pt>
                <c:pt idx="5">
                  <c:v>0.875</c:v>
                </c:pt>
                <c:pt idx="6">
                  <c:v>0.875</c:v>
                </c:pt>
                <c:pt idx="7">
                  <c:v>0.875</c:v>
                </c:pt>
                <c:pt idx="8">
                  <c:v>0.875</c:v>
                </c:pt>
                <c:pt idx="9">
                  <c:v>0.58333333333333337</c:v>
                </c:pt>
                <c:pt idx="10">
                  <c:v>0.58333333333333337</c:v>
                </c:pt>
                <c:pt idx="11">
                  <c:v>0.29166666666666669</c:v>
                </c:pt>
                <c:pt idx="12">
                  <c:v>0.291666666666666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23B-4C59-90FD-4E3881D06544}"/>
            </c:ext>
          </c:extLst>
        </c:ser>
        <c:ser>
          <c:idx val="1"/>
          <c:order val="1"/>
          <c:tx>
            <c:v>低</c:v>
          </c:tx>
          <c:spPr>
            <a:ln w="28575">
              <a:solidFill>
                <a:srgbClr val="548235"/>
              </a:solidFill>
            </a:ln>
          </c:spPr>
          <c:marker>
            <c:symbol val="circle"/>
            <c:size val="4"/>
            <c:spPr>
              <a:solidFill>
                <a:srgbClr val="548235"/>
              </a:solidFill>
              <a:ln>
                <a:solidFill>
                  <a:srgbClr val="548235"/>
                </a:solidFill>
              </a:ln>
            </c:spPr>
          </c:marker>
          <c:xVal>
            <c:numLit>
              <c:formatCode>General</c:formatCode>
              <c:ptCount val="44"/>
              <c:pt idx="0">
                <c:v>0</c:v>
              </c:pt>
              <c:pt idx="1">
                <c:v>14</c:v>
              </c:pt>
              <c:pt idx="2">
                <c:v>14</c:v>
              </c:pt>
              <c:pt idx="3">
                <c:v>14</c:v>
              </c:pt>
              <c:pt idx="4">
                <c:v>14</c:v>
              </c:pt>
              <c:pt idx="5">
                <c:v>17</c:v>
              </c:pt>
              <c:pt idx="6">
                <c:v>17</c:v>
              </c:pt>
              <c:pt idx="7">
                <c:v>24</c:v>
              </c:pt>
              <c:pt idx="8">
                <c:v>24</c:v>
              </c:pt>
              <c:pt idx="9">
                <c:v>35</c:v>
              </c:pt>
              <c:pt idx="10">
                <c:v>35</c:v>
              </c:pt>
              <c:pt idx="11">
                <c:v>44</c:v>
              </c:pt>
              <c:pt idx="12">
                <c:v>47</c:v>
              </c:pt>
              <c:pt idx="13">
                <c:v>47</c:v>
              </c:pt>
              <c:pt idx="14">
                <c:v>51</c:v>
              </c:pt>
              <c:pt idx="15">
                <c:v>51</c:v>
              </c:pt>
              <c:pt idx="16">
                <c:v>69</c:v>
              </c:pt>
              <c:pt idx="17">
                <c:v>69</c:v>
              </c:pt>
              <c:pt idx="18">
                <c:v>77</c:v>
              </c:pt>
              <c:pt idx="19">
                <c:v>82</c:v>
              </c:pt>
              <c:pt idx="20">
                <c:v>82</c:v>
              </c:pt>
              <c:pt idx="21">
                <c:v>90</c:v>
              </c:pt>
              <c:pt idx="22">
                <c:v>102</c:v>
              </c:pt>
              <c:pt idx="23">
                <c:v>102</c:v>
              </c:pt>
              <c:pt idx="24">
                <c:v>114</c:v>
              </c:pt>
              <c:pt idx="25">
                <c:v>145</c:v>
              </c:pt>
              <c:pt idx="26">
                <c:v>145</c:v>
              </c:pt>
              <c:pt idx="27">
                <c:v>147</c:v>
              </c:pt>
              <c:pt idx="28">
                <c:v>147</c:v>
              </c:pt>
              <c:pt idx="29">
                <c:v>156</c:v>
              </c:pt>
              <c:pt idx="30">
                <c:v>156</c:v>
              </c:pt>
              <c:pt idx="31">
                <c:v>156</c:v>
              </c:pt>
              <c:pt idx="32">
                <c:v>156</c:v>
              </c:pt>
              <c:pt idx="33">
                <c:v>160</c:v>
              </c:pt>
              <c:pt idx="34">
                <c:v>160</c:v>
              </c:pt>
              <c:pt idx="35">
                <c:v>176</c:v>
              </c:pt>
              <c:pt idx="36">
                <c:v>182</c:v>
              </c:pt>
              <c:pt idx="37">
                <c:v>182</c:v>
              </c:pt>
              <c:pt idx="38">
                <c:v>198</c:v>
              </c:pt>
              <c:pt idx="39">
                <c:v>198</c:v>
              </c:pt>
              <c:pt idx="40">
                <c:v>203</c:v>
              </c:pt>
              <c:pt idx="41">
                <c:v>203</c:v>
              </c:pt>
              <c:pt idx="42">
                <c:v>290</c:v>
              </c:pt>
              <c:pt idx="43">
                <c:v>290</c:v>
              </c:pt>
            </c:numLit>
          </c:xVal>
          <c:yVal>
            <c:numLit>
              <c:formatCode>General</c:formatCode>
              <c:ptCount val="44"/>
              <c:pt idx="0">
                <c:v>1</c:v>
              </c:pt>
              <c:pt idx="1">
                <c:v>1</c:v>
              </c:pt>
              <c:pt idx="2">
                <c:v>0.95833333333333337</c:v>
              </c:pt>
              <c:pt idx="3">
                <c:v>0.95833333333333337</c:v>
              </c:pt>
              <c:pt idx="4">
                <c:v>0.91666666666666674</c:v>
              </c:pt>
              <c:pt idx="5">
                <c:v>0.91666666666666674</c:v>
              </c:pt>
              <c:pt idx="6">
                <c:v>0.87500000000000011</c:v>
              </c:pt>
              <c:pt idx="7">
                <c:v>0.87500000000000011</c:v>
              </c:pt>
              <c:pt idx="8">
                <c:v>0.83333333333333348</c:v>
              </c:pt>
              <c:pt idx="9">
                <c:v>0.83333333333333348</c:v>
              </c:pt>
              <c:pt idx="10">
                <c:v>0.79166666666666685</c:v>
              </c:pt>
              <c:pt idx="11">
                <c:v>0.79166666666666685</c:v>
              </c:pt>
              <c:pt idx="12">
                <c:v>0.79166666666666685</c:v>
              </c:pt>
              <c:pt idx="13">
                <c:v>0.74768518518518534</c:v>
              </c:pt>
              <c:pt idx="14">
                <c:v>0.74768518518518534</c:v>
              </c:pt>
              <c:pt idx="15">
                <c:v>0.70370370370370383</c:v>
              </c:pt>
              <c:pt idx="16">
                <c:v>0.70370370370370383</c:v>
              </c:pt>
              <c:pt idx="17">
                <c:v>0.65972222222222232</c:v>
              </c:pt>
              <c:pt idx="18">
                <c:v>0.65972222222222232</c:v>
              </c:pt>
              <c:pt idx="19">
                <c:v>0.65972222222222232</c:v>
              </c:pt>
              <c:pt idx="20">
                <c:v>0.61259920634920639</c:v>
              </c:pt>
              <c:pt idx="21">
                <c:v>0.61259920634920639</c:v>
              </c:pt>
              <c:pt idx="22">
                <c:v>0.61259920634920639</c:v>
              </c:pt>
              <c:pt idx="23">
                <c:v>0.56154927248677255</c:v>
              </c:pt>
              <c:pt idx="24">
                <c:v>0.56154927248677255</c:v>
              </c:pt>
              <c:pt idx="25">
                <c:v>0.56154927248677255</c:v>
              </c:pt>
              <c:pt idx="26">
                <c:v>0.50539434523809534</c:v>
              </c:pt>
              <c:pt idx="27">
                <c:v>0.50539434523809534</c:v>
              </c:pt>
              <c:pt idx="28">
                <c:v>0.44923941798941808</c:v>
              </c:pt>
              <c:pt idx="29">
                <c:v>0.44923941798941808</c:v>
              </c:pt>
              <c:pt idx="30">
                <c:v>0.39308449074074081</c:v>
              </c:pt>
              <c:pt idx="31">
                <c:v>0.39308449074074081</c:v>
              </c:pt>
              <c:pt idx="32">
                <c:v>0.33692956349206354</c:v>
              </c:pt>
              <c:pt idx="33">
                <c:v>0.33692956349206354</c:v>
              </c:pt>
              <c:pt idx="34">
                <c:v>0.28077463624338628</c:v>
              </c:pt>
              <c:pt idx="35">
                <c:v>0.28077463624338628</c:v>
              </c:pt>
              <c:pt idx="36">
                <c:v>0.28077463624338628</c:v>
              </c:pt>
              <c:pt idx="37">
                <c:v>0.21058097718253971</c:v>
              </c:pt>
              <c:pt idx="38">
                <c:v>0.21058097718253971</c:v>
              </c:pt>
              <c:pt idx="39">
                <c:v>0.14038731812169314</c:v>
              </c:pt>
              <c:pt idx="40">
                <c:v>0.14038731812169314</c:v>
              </c:pt>
              <c:pt idx="41">
                <c:v>7.0193659060846569E-2</c:v>
              </c:pt>
              <c:pt idx="42">
                <c:v>7.0193659060846569E-2</c:v>
              </c:pt>
              <c:pt idx="43">
                <c:v>0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1-923B-4C59-90FD-4E3881D065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2644352"/>
        <c:axId val="692641728"/>
      </c:scatterChart>
      <c:valAx>
        <c:axId val="6926443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9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ja-JP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after ADA induction (weeks)</a:t>
                </a:r>
                <a:endParaRPr lang="ja-JP" altLang="en-US" sz="9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692641728"/>
        <c:crosses val="autoZero"/>
        <c:crossBetween val="midCat"/>
      </c:valAx>
      <c:valAx>
        <c:axId val="692641728"/>
        <c:scaling>
          <c:orientation val="minMax"/>
          <c:max val="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9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ja-JP" sz="9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rsistence</a:t>
                </a:r>
                <a:r>
                  <a:rPr lang="en-US" altLang="ja-JP" sz="900" b="0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ates with ADA</a:t>
                </a:r>
                <a:endParaRPr lang="ja-JP" altLang="en-US" sz="9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692644352"/>
        <c:crosses val="autoZero"/>
        <c:crossBetween val="midCat"/>
      </c:valAx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ln>
      <a:solidFill>
        <a:schemeClr val="bg2">
          <a:lumMod val="75000"/>
        </a:schemeClr>
      </a:solidFill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95A43F-FCEE-427D-B846-C6A88099F7DC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DA7399-BE28-4891-8DA3-9130936400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81653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4FDEC-D2EA-4B6A-9A9C-9572ECEA38B4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3B93E-415D-43CD-8BBE-E82E83CA01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7024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4FDEC-D2EA-4B6A-9A9C-9572ECEA38B4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3B93E-415D-43CD-8BBE-E82E83CA01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5869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4FDEC-D2EA-4B6A-9A9C-9572ECEA38B4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3B93E-415D-43CD-8BBE-E82E83CA01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1754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4FDEC-D2EA-4B6A-9A9C-9572ECEA38B4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3B93E-415D-43CD-8BBE-E82E83CA01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042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4FDEC-D2EA-4B6A-9A9C-9572ECEA38B4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3B93E-415D-43CD-8BBE-E82E83CA01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7466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4FDEC-D2EA-4B6A-9A9C-9572ECEA38B4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3B93E-415D-43CD-8BBE-E82E83CA01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58435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4FDEC-D2EA-4B6A-9A9C-9572ECEA38B4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3B93E-415D-43CD-8BBE-E82E83CA01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6756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4FDEC-D2EA-4B6A-9A9C-9572ECEA38B4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3B93E-415D-43CD-8BBE-E82E83CA01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5924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4FDEC-D2EA-4B6A-9A9C-9572ECEA38B4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3B93E-415D-43CD-8BBE-E82E83CA01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787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4FDEC-D2EA-4B6A-9A9C-9572ECEA38B4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3B93E-415D-43CD-8BBE-E82E83CA01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5575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4FDEC-D2EA-4B6A-9A9C-9572ECEA38B4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3B93E-415D-43CD-8BBE-E82E83CA01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8905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34FDEC-D2EA-4B6A-9A9C-9572ECEA38B4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D3B93E-415D-43CD-8BBE-E82E83CA01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0313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DD0F565-6C5C-4EEF-B80F-0F1C2B64750C}"/>
              </a:ext>
            </a:extLst>
          </p:cNvPr>
          <p:cNvSpPr txBox="1"/>
          <p:nvPr/>
        </p:nvSpPr>
        <p:spPr>
          <a:xfrm>
            <a:off x="1629000" y="576654"/>
            <a:ext cx="2841970" cy="276999"/>
          </a:xfrm>
          <a:prstGeom prst="rect">
            <a:avLst/>
          </a:prstGeom>
          <a:noFill/>
          <a:ln>
            <a:noFill/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 defTabSz="257175">
              <a:defRPr/>
            </a:pPr>
            <a:r>
              <a:rPr lang="en-US" altLang="ja-JP" sz="1200" dirty="0">
                <a:solidFill>
                  <a:srgbClr val="231F2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</a:t>
            </a:r>
            <a:endParaRPr kumimoji="0" lang="ja-JP" altLang="en-US" sz="1200" dirty="0">
              <a:solidFill>
                <a:prstClr val="black"/>
              </a:solidFill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16EB813D-5B8F-453D-9D2B-CC58D7C14A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5029846"/>
              </p:ext>
            </p:extLst>
          </p:nvPr>
        </p:nvGraphicFramePr>
        <p:xfrm>
          <a:off x="1629000" y="1605568"/>
          <a:ext cx="3600000" cy="30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A39F4A0F-C568-43C8-8F81-8177C43D0BFE}"/>
              </a:ext>
            </a:extLst>
          </p:cNvPr>
          <p:cNvCxnSpPr>
            <a:cxnSpLocks/>
          </p:cNvCxnSpPr>
          <p:nvPr/>
        </p:nvCxnSpPr>
        <p:spPr>
          <a:xfrm>
            <a:off x="3994452" y="1808941"/>
            <a:ext cx="210546" cy="0"/>
          </a:xfrm>
          <a:prstGeom prst="line">
            <a:avLst/>
          </a:prstGeom>
          <a:ln w="28575">
            <a:solidFill>
              <a:schemeClr val="accent2">
                <a:lumMod val="75000"/>
              </a:schemeClr>
            </a:solidFill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B35BC8A5-6A5A-4D78-9714-E2554E516C97}"/>
              </a:ext>
            </a:extLst>
          </p:cNvPr>
          <p:cNvCxnSpPr>
            <a:cxnSpLocks/>
          </p:cNvCxnSpPr>
          <p:nvPr/>
        </p:nvCxnSpPr>
        <p:spPr>
          <a:xfrm>
            <a:off x="3994452" y="2054935"/>
            <a:ext cx="210546" cy="0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8AB46D7-73AE-4FC4-87F3-A5E60174444C}"/>
              </a:ext>
            </a:extLst>
          </p:cNvPr>
          <p:cNvSpPr txBox="1"/>
          <p:nvPr/>
        </p:nvSpPr>
        <p:spPr>
          <a:xfrm>
            <a:off x="4197471" y="1692935"/>
            <a:ext cx="9292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 drug level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32E44C0-96CC-4D57-B87F-AC7867990318}"/>
              </a:ext>
            </a:extLst>
          </p:cNvPr>
          <p:cNvSpPr txBox="1"/>
          <p:nvPr/>
        </p:nvSpPr>
        <p:spPr>
          <a:xfrm>
            <a:off x="4197472" y="1938929"/>
            <a:ext cx="8469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 drug level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42A85E2-5024-45EC-B178-5AABCF1FF9E4}"/>
              </a:ext>
            </a:extLst>
          </p:cNvPr>
          <p:cNvSpPr txBox="1"/>
          <p:nvPr/>
        </p:nvSpPr>
        <p:spPr>
          <a:xfrm>
            <a:off x="1629000" y="1268948"/>
            <a:ext cx="402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E181A78E-8983-4FC4-8F1D-527BD37267D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06808188"/>
              </p:ext>
            </p:extLst>
          </p:nvPr>
        </p:nvGraphicFramePr>
        <p:xfrm>
          <a:off x="1629000" y="5484157"/>
          <a:ext cx="3600000" cy="30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A37A5EDC-8FD6-477F-9A2A-7F4A501F0D21}"/>
              </a:ext>
            </a:extLst>
          </p:cNvPr>
          <p:cNvCxnSpPr>
            <a:cxnSpLocks/>
          </p:cNvCxnSpPr>
          <p:nvPr/>
        </p:nvCxnSpPr>
        <p:spPr>
          <a:xfrm>
            <a:off x="3994452" y="5710381"/>
            <a:ext cx="210546" cy="0"/>
          </a:xfrm>
          <a:prstGeom prst="line">
            <a:avLst/>
          </a:prstGeom>
          <a:ln w="28575">
            <a:solidFill>
              <a:schemeClr val="accent2">
                <a:lumMod val="75000"/>
              </a:schemeClr>
            </a:solidFill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A24B2A43-DCDC-4220-8E67-1FED102CBAC1}"/>
              </a:ext>
            </a:extLst>
          </p:cNvPr>
          <p:cNvCxnSpPr>
            <a:cxnSpLocks/>
          </p:cNvCxnSpPr>
          <p:nvPr/>
        </p:nvCxnSpPr>
        <p:spPr>
          <a:xfrm>
            <a:off x="3994452" y="5956375"/>
            <a:ext cx="210546" cy="0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</a:ln>
        </p:spPr>
        <p:style>
          <a:lnRef idx="3">
            <a:schemeClr val="accent5"/>
          </a:lnRef>
          <a:fillRef idx="0">
            <a:schemeClr val="accent5"/>
          </a:fillRef>
          <a:effectRef idx="2">
            <a:schemeClr val="accent5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632DBED-CC0C-4A27-B181-5EE37A219974}"/>
              </a:ext>
            </a:extLst>
          </p:cNvPr>
          <p:cNvSpPr txBox="1"/>
          <p:nvPr/>
        </p:nvSpPr>
        <p:spPr>
          <a:xfrm>
            <a:off x="4197471" y="5594375"/>
            <a:ext cx="9292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 drug level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4B2C630-EB00-4AAE-878D-DE018C088C7C}"/>
              </a:ext>
            </a:extLst>
          </p:cNvPr>
          <p:cNvSpPr txBox="1"/>
          <p:nvPr/>
        </p:nvSpPr>
        <p:spPr>
          <a:xfrm>
            <a:off x="4197472" y="5840369"/>
            <a:ext cx="8469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 drug level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C5F77E0-0703-4A1A-9581-9D1C7F0D2C3C}"/>
              </a:ext>
            </a:extLst>
          </p:cNvPr>
          <p:cNvSpPr txBox="1"/>
          <p:nvPr/>
        </p:nvSpPr>
        <p:spPr>
          <a:xfrm>
            <a:off x="1629000" y="5130504"/>
            <a:ext cx="402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3794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37</TotalTime>
  <Words>39</Words>
  <Application>Microsoft Office PowerPoint</Application>
  <PresentationFormat>A4 210 x 297 mm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雅一 加藤</dc:creator>
  <cp:lastModifiedBy>杉本 健</cp:lastModifiedBy>
  <cp:revision>72</cp:revision>
  <dcterms:created xsi:type="dcterms:W3CDTF">2020-06-30T08:08:01Z</dcterms:created>
  <dcterms:modified xsi:type="dcterms:W3CDTF">2021-06-06T08:36:48Z</dcterms:modified>
</cp:coreProperties>
</file>